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78"/>
    <p:restoredTop sz="94694"/>
  </p:normalViewPr>
  <p:slideViewPr>
    <p:cSldViewPr snapToGrid="0" showGuides="1">
      <p:cViewPr>
        <p:scale>
          <a:sx n="195" d="100"/>
          <a:sy n="195" d="100"/>
        </p:scale>
        <p:origin x="1256" y="-66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760603-7B14-AB44-9DE1-E2EF40323409}" type="datetimeFigureOut">
              <a:t>2024/4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94390D-E830-D04E-8250-9146598888EA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9504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4258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565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913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19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412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51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511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944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85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853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5674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2475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9AE1E9-8E6C-8FF8-8146-3CE089DD52B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B5CA1C0D-24D5-9CEC-18AC-4CBA4BC739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43903" y="7105910"/>
            <a:ext cx="570983" cy="1099866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64FF733-E757-8701-81EB-7C1E050B189D}"/>
              </a:ext>
            </a:extLst>
          </p:cNvPr>
          <p:cNvSpPr txBox="1"/>
          <p:nvPr/>
        </p:nvSpPr>
        <p:spPr>
          <a:xfrm>
            <a:off x="1386029" y="8464100"/>
            <a:ext cx="458910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D-Genies-generated dot-plots showing similarities of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bulbocastan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with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phureja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(a) and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multidissect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(b).</a:t>
            </a:r>
            <a:endParaRPr kumimoji="1"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CDEEA62-760C-E676-AA9D-6B592D91145E}"/>
              </a:ext>
            </a:extLst>
          </p:cNvPr>
          <p:cNvSpPr txBox="1"/>
          <p:nvPr/>
        </p:nvSpPr>
        <p:spPr>
          <a:xfrm>
            <a:off x="2692671" y="771973"/>
            <a:ext cx="12971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phureja </a:t>
            </a:r>
            <a:r>
              <a:rPr kumimoji="1" lang="en-US" altLang="ja-JP" sz="800">
                <a:latin typeface="Helvetica" pitchFamily="2" charset="0"/>
              </a:rPr>
              <a:t>DM8.1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" name="テキスト ボックス 27">
            <a:extLst>
              <a:ext uri="{FF2B5EF4-FFF2-40B4-BE49-F238E27FC236}">
                <a16:creationId xmlns:a16="http://schemas.microsoft.com/office/drawing/2014/main" id="{0E5F2E05-21D7-5941-3C34-4F3A25834F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4663" y="4688124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>
                <a:latin typeface="Helvetica" pitchFamily="2" charset="0"/>
              </a:rPr>
              <a:t>b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" name="テキスト ボックス 26">
            <a:extLst>
              <a:ext uri="{FF2B5EF4-FFF2-40B4-BE49-F238E27FC236}">
                <a16:creationId xmlns:a16="http://schemas.microsoft.com/office/drawing/2014/main" id="{B2211389-6B96-99B0-EA1A-39D785CCFB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4664" y="879695"/>
            <a:ext cx="339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>
                <a:latin typeface="Helvetica" pitchFamily="2" charset="0"/>
              </a:rPr>
              <a:t>a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A3FF8885-9A61-25B2-AF89-5F7A6F996F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4323" y="968563"/>
            <a:ext cx="3553846" cy="3546836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C6E2DD2-DE7E-FDFA-0DE0-9DB61A0762EF}"/>
              </a:ext>
            </a:extLst>
          </p:cNvPr>
          <p:cNvSpPr txBox="1"/>
          <p:nvPr/>
        </p:nvSpPr>
        <p:spPr>
          <a:xfrm rot="5400000">
            <a:off x="4418515" y="2553639"/>
            <a:ext cx="16546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bulbocastanum </a:t>
            </a:r>
            <a:r>
              <a:rPr kumimoji="1" lang="en-US" altLang="ja-JP" sz="800">
                <a:latin typeface="Helvetica" pitchFamily="2" charset="0"/>
              </a:rPr>
              <a:t>11H21</a:t>
            </a:r>
            <a:endParaRPr kumimoji="1" lang="ja-JP" altLang="en-US" sz="800">
              <a:latin typeface="Helvetica" pitchFamily="2" charset="0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6BC05891-551F-099C-4F25-D9DEAB7239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64323" y="4781092"/>
            <a:ext cx="3553846" cy="3553846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055FBC3-1824-369F-EB66-C63778F15064}"/>
              </a:ext>
            </a:extLst>
          </p:cNvPr>
          <p:cNvSpPr txBox="1"/>
          <p:nvPr/>
        </p:nvSpPr>
        <p:spPr>
          <a:xfrm>
            <a:off x="2486685" y="4580402"/>
            <a:ext cx="17091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multidissectum </a:t>
            </a:r>
            <a:r>
              <a:rPr kumimoji="1" lang="en-US" altLang="ja-JP" sz="800">
                <a:latin typeface="Helvetica" pitchFamily="2" charset="0"/>
              </a:rPr>
              <a:t>PG5068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33A5FB7-C43C-9D24-A527-BA8C601E7CFD}"/>
              </a:ext>
            </a:extLst>
          </p:cNvPr>
          <p:cNvSpPr txBox="1"/>
          <p:nvPr/>
        </p:nvSpPr>
        <p:spPr>
          <a:xfrm rot="5400000">
            <a:off x="4418515" y="6371493"/>
            <a:ext cx="16546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bulbocastanum </a:t>
            </a:r>
            <a:r>
              <a:rPr kumimoji="1" lang="en-US" altLang="ja-JP" sz="800">
                <a:latin typeface="Helvetica" pitchFamily="2" charset="0"/>
              </a:rPr>
              <a:t>11H21</a:t>
            </a:r>
            <a:endParaRPr kumimoji="1" lang="ja-JP" altLang="en-US" sz="8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81898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29</TotalTime>
  <Words>42</Words>
  <Application>Microsoft Macintosh PowerPoint</Application>
  <PresentationFormat>A4 210 x 297 mm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yoshi Hosaka</dc:creator>
  <cp:lastModifiedBy>*</cp:lastModifiedBy>
  <cp:revision>11</cp:revision>
  <dcterms:created xsi:type="dcterms:W3CDTF">2023-11-03T07:37:49Z</dcterms:created>
  <dcterms:modified xsi:type="dcterms:W3CDTF">2024-04-19T22:53:11Z</dcterms:modified>
</cp:coreProperties>
</file>